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F21BAA3-53CA-41BA-B279-83B66CBE305B}" v="6" dt="2021-12-01T05:41:09.1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eryl Lohr" userId="f5a9862d-80a0-42d8-b2bc-7595befa977e" providerId="ADAL" clId="{7F21BAA3-53CA-41BA-B279-83B66CBE305B}"/>
    <pc:docChg chg="custSel modSld">
      <pc:chgData name="Cheryl Lohr" userId="f5a9862d-80a0-42d8-b2bc-7595befa977e" providerId="ADAL" clId="{7F21BAA3-53CA-41BA-B279-83B66CBE305B}" dt="2021-12-01T05:41:18.515" v="62" actId="167"/>
      <pc:docMkLst>
        <pc:docMk/>
      </pc:docMkLst>
      <pc:sldChg chg="addSp delSp modSp mod">
        <pc:chgData name="Cheryl Lohr" userId="f5a9862d-80a0-42d8-b2bc-7595befa977e" providerId="ADAL" clId="{7F21BAA3-53CA-41BA-B279-83B66CBE305B}" dt="2021-12-01T05:41:18.515" v="62" actId="167"/>
        <pc:sldMkLst>
          <pc:docMk/>
          <pc:sldMk cId="2366640984" sldId="256"/>
        </pc:sldMkLst>
        <pc:spChg chg="mod">
          <ac:chgData name="Cheryl Lohr" userId="f5a9862d-80a0-42d8-b2bc-7595befa977e" providerId="ADAL" clId="{7F21BAA3-53CA-41BA-B279-83B66CBE305B}" dt="2021-12-01T05:38:57.017" v="54" actId="20577"/>
          <ac:spMkLst>
            <pc:docMk/>
            <pc:sldMk cId="2366640984" sldId="256"/>
            <ac:spMk id="3" creationId="{F0291525-FE15-4EA0-8EAC-2A000A8F3C65}"/>
          </ac:spMkLst>
        </pc:spChg>
        <pc:spChg chg="mod topLvl">
          <ac:chgData name="Cheryl Lohr" userId="f5a9862d-80a0-42d8-b2bc-7595befa977e" providerId="ADAL" clId="{7F21BAA3-53CA-41BA-B279-83B66CBE305B}" dt="2021-12-01T05:40:09.639" v="55" actId="165"/>
          <ac:spMkLst>
            <pc:docMk/>
            <pc:sldMk cId="2366640984" sldId="256"/>
            <ac:spMk id="10" creationId="{4FFD5343-1B97-4093-9149-60A63905505B}"/>
          </ac:spMkLst>
        </pc:spChg>
        <pc:spChg chg="mod topLvl">
          <ac:chgData name="Cheryl Lohr" userId="f5a9862d-80a0-42d8-b2bc-7595befa977e" providerId="ADAL" clId="{7F21BAA3-53CA-41BA-B279-83B66CBE305B}" dt="2021-12-01T05:40:09.639" v="55" actId="165"/>
          <ac:spMkLst>
            <pc:docMk/>
            <pc:sldMk cId="2366640984" sldId="256"/>
            <ac:spMk id="11" creationId="{0C4D2828-A78D-44E2-B671-F221669D46E3}"/>
          </ac:spMkLst>
        </pc:spChg>
        <pc:spChg chg="mod topLvl">
          <ac:chgData name="Cheryl Lohr" userId="f5a9862d-80a0-42d8-b2bc-7595befa977e" providerId="ADAL" clId="{7F21BAA3-53CA-41BA-B279-83B66CBE305B}" dt="2021-12-01T05:40:09.639" v="55" actId="165"/>
          <ac:spMkLst>
            <pc:docMk/>
            <pc:sldMk cId="2366640984" sldId="256"/>
            <ac:spMk id="12" creationId="{A799A9B8-F16D-4229-8662-CD3589C349FD}"/>
          </ac:spMkLst>
        </pc:spChg>
        <pc:grpChg chg="add del mod topLvl">
          <ac:chgData name="Cheryl Lohr" userId="f5a9862d-80a0-42d8-b2bc-7595befa977e" providerId="ADAL" clId="{7F21BAA3-53CA-41BA-B279-83B66CBE305B}" dt="2021-12-01T05:40:16.218" v="56" actId="165"/>
          <ac:grpSpMkLst>
            <pc:docMk/>
            <pc:sldMk cId="2366640984" sldId="256"/>
            <ac:grpSpMk id="17" creationId="{9892F2E6-8B39-49E4-93DC-2731C196B174}"/>
          </ac:grpSpMkLst>
        </pc:grpChg>
        <pc:grpChg chg="add del mod ord">
          <ac:chgData name="Cheryl Lohr" userId="f5a9862d-80a0-42d8-b2bc-7595befa977e" providerId="ADAL" clId="{7F21BAA3-53CA-41BA-B279-83B66CBE305B}" dt="2021-12-01T05:40:09.639" v="55" actId="165"/>
          <ac:grpSpMkLst>
            <pc:docMk/>
            <pc:sldMk cId="2366640984" sldId="256"/>
            <ac:grpSpMk id="18" creationId="{C7B708CB-5C05-4567-853B-EF46ED874F9A}"/>
          </ac:grpSpMkLst>
        </pc:grpChg>
        <pc:picChg chg="del mod topLvl">
          <ac:chgData name="Cheryl Lohr" userId="f5a9862d-80a0-42d8-b2bc-7595befa977e" providerId="ADAL" clId="{7F21BAA3-53CA-41BA-B279-83B66CBE305B}" dt="2021-12-01T05:40:18.490" v="57" actId="478"/>
          <ac:picMkLst>
            <pc:docMk/>
            <pc:sldMk cId="2366640984" sldId="256"/>
            <ac:picMk id="7" creationId="{65956AD0-D0E8-4FB4-93D4-C0204D3518A0}"/>
          </ac:picMkLst>
        </pc:picChg>
        <pc:picChg chg="mod topLvl">
          <ac:chgData name="Cheryl Lohr" userId="f5a9862d-80a0-42d8-b2bc-7595befa977e" providerId="ADAL" clId="{7F21BAA3-53CA-41BA-B279-83B66CBE305B}" dt="2021-12-01T05:40:16.218" v="56" actId="165"/>
          <ac:picMkLst>
            <pc:docMk/>
            <pc:sldMk cId="2366640984" sldId="256"/>
            <ac:picMk id="14" creationId="{0A7A79D6-6BF7-4D53-864C-5B66996C4BEA}"/>
          </ac:picMkLst>
        </pc:picChg>
        <pc:picChg chg="add mod ord topLvl">
          <ac:chgData name="Cheryl Lohr" userId="f5a9862d-80a0-42d8-b2bc-7595befa977e" providerId="ADAL" clId="{7F21BAA3-53CA-41BA-B279-83B66CBE305B}" dt="2021-12-01T05:40:16.218" v="56" actId="165"/>
          <ac:picMkLst>
            <pc:docMk/>
            <pc:sldMk cId="2366640984" sldId="256"/>
            <ac:picMk id="16" creationId="{DFD1B6B3-0E1C-413A-8FF6-2529BB3B792C}"/>
          </ac:picMkLst>
        </pc:picChg>
        <pc:picChg chg="add mod ord">
          <ac:chgData name="Cheryl Lohr" userId="f5a9862d-80a0-42d8-b2bc-7595befa977e" providerId="ADAL" clId="{7F21BAA3-53CA-41BA-B279-83B66CBE305B}" dt="2021-12-01T05:41:18.515" v="62" actId="167"/>
          <ac:picMkLst>
            <pc:docMk/>
            <pc:sldMk cId="2366640984" sldId="256"/>
            <ac:picMk id="20" creationId="{DE468914-E886-441C-8B6D-A218CE3BC62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67573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4881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55380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320838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6291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605730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49115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64082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8478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62437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4739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359EBD-2FD7-4FF0-80FA-824BE616AE5A}" type="datetimeFigureOut">
              <a:rPr lang="en-AU" smtClean="0"/>
              <a:t>15/12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BD459F-2A61-4AD6-95EF-5AE1DEA2FC0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90388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 descr="Chart&#10;&#10;Description automatically generated">
            <a:extLst>
              <a:ext uri="{FF2B5EF4-FFF2-40B4-BE49-F238E27FC236}">
                <a16:creationId xmlns:a16="http://schemas.microsoft.com/office/drawing/2014/main" id="{DE468914-E886-441C-8B6D-A218CE3BC6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438" y="5849654"/>
            <a:ext cx="6400800" cy="2743200"/>
          </a:xfrm>
          <a:prstGeom prst="rect">
            <a:avLst/>
          </a:prstGeom>
        </p:spPr>
      </p:pic>
      <p:pic>
        <p:nvPicPr>
          <p:cNvPr id="16" name="Picture 15" descr="Chart&#10;&#10;Description automatically generated">
            <a:extLst>
              <a:ext uri="{FF2B5EF4-FFF2-40B4-BE49-F238E27FC236}">
                <a16:creationId xmlns:a16="http://schemas.microsoft.com/office/drawing/2014/main" id="{DFD1B6B3-0E1C-413A-8FF6-2529BB3B792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438" y="3017729"/>
            <a:ext cx="6400800" cy="2743200"/>
          </a:xfrm>
          <a:prstGeom prst="rect">
            <a:avLst/>
          </a:prstGeom>
        </p:spPr>
      </p:pic>
      <p:pic>
        <p:nvPicPr>
          <p:cNvPr id="14" name="Picture 13" descr="Chart&#10;&#10;Description automatically generated with medium confidence">
            <a:extLst>
              <a:ext uri="{FF2B5EF4-FFF2-40B4-BE49-F238E27FC236}">
                <a16:creationId xmlns:a16="http://schemas.microsoft.com/office/drawing/2014/main" id="{0A7A79D6-6BF7-4D53-864C-5B66996C4BE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438" y="185804"/>
            <a:ext cx="6400800" cy="27432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FFD5343-1B97-4093-9149-60A63905505B}"/>
              </a:ext>
            </a:extLst>
          </p:cNvPr>
          <p:cNvSpPr txBox="1"/>
          <p:nvPr/>
        </p:nvSpPr>
        <p:spPr>
          <a:xfrm>
            <a:off x="196762" y="1138"/>
            <a:ext cx="475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A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C4D2828-A78D-44E2-B671-F221669D46E3}"/>
              </a:ext>
            </a:extLst>
          </p:cNvPr>
          <p:cNvSpPr txBox="1"/>
          <p:nvPr/>
        </p:nvSpPr>
        <p:spPr>
          <a:xfrm>
            <a:off x="196763" y="2744338"/>
            <a:ext cx="475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B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799A9B8-F16D-4229-8662-CD3589C349FD}"/>
              </a:ext>
            </a:extLst>
          </p:cNvPr>
          <p:cNvSpPr txBox="1"/>
          <p:nvPr/>
        </p:nvSpPr>
        <p:spPr>
          <a:xfrm>
            <a:off x="209290" y="5620626"/>
            <a:ext cx="4759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/>
              <a:t>C)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291525-FE15-4EA0-8EAC-2A000A8F3C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0" y="8592854"/>
            <a:ext cx="6858000" cy="1313145"/>
          </a:xfrm>
        </p:spPr>
        <p:txBody>
          <a:bodyPr>
            <a:normAutofit lnSpcReduction="10000"/>
          </a:bodyPr>
          <a:lstStyle/>
          <a:p>
            <a:pPr algn="l"/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Information, </a:t>
            </a:r>
            <a:r>
              <a:rPr lang="en-AU" sz="120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istograms of the time interval or distance between cat detections on Matuwa with function </a:t>
            </a:r>
            <a:r>
              <a:rPr lang="en-AU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cet_zoom</a:t>
            </a:r>
            <a:r>
              <a:rPr lang="en-A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package </a:t>
            </a:r>
            <a:r>
              <a:rPr lang="en-AU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force</a:t>
            </a:r>
            <a:r>
              <a:rPr lang="en-A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ed to highlight the pattern in the data. A) photos from 120 camera-traps spaced using a stratified random design and installed between 2018 and 2020, 96.7% of photos are &lt;5 minutes apart. B) photos from 130 camera-traps spaced using 1 km grid design and installed in 2020 and 2021, 99.5% of photos are &lt;5 minutes apart. C) distance between sets of cat tracks, 92.3% of tracks are &lt;1 km apart and usually caused by cats that travelled along roads leaving a continuous set of prints, which were documented has having left one discrete set of prints every 100 m for the purposes of this analysis.</a:t>
            </a:r>
          </a:p>
        </p:txBody>
      </p:sp>
    </p:spTree>
    <p:extLst>
      <p:ext uri="{BB962C8B-B14F-4D97-AF65-F5344CB8AC3E}">
        <p14:creationId xmlns:p14="http://schemas.microsoft.com/office/powerpoint/2010/main" val="2366640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154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ryl Lohr</dc:creator>
  <cp:lastModifiedBy>MDPI-13</cp:lastModifiedBy>
  <cp:revision>2</cp:revision>
  <dcterms:created xsi:type="dcterms:W3CDTF">2021-12-01T05:11:31Z</dcterms:created>
  <dcterms:modified xsi:type="dcterms:W3CDTF">2021-12-15T09:46:28Z</dcterms:modified>
</cp:coreProperties>
</file>